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259388" cy="25590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AC606-EC8D-4DCA-A0BF-70E9E107CA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47307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63160" y="1479960"/>
            <a:ext cx="47307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73E0F-9396-4E26-85D0-E09468950B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687400" y="59688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63160" y="147996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687400" y="147996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BB253-8E44-4C54-A9CB-3BAC74FCCD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15231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863000" y="596880"/>
            <a:ext cx="15231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462480" y="596880"/>
            <a:ext cx="15231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63160" y="1479960"/>
            <a:ext cx="15231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863000" y="1479960"/>
            <a:ext cx="15231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462480" y="1479960"/>
            <a:ext cx="15231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4C333-B971-4803-9761-3CCBB81D1D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63160" y="596880"/>
            <a:ext cx="4730760" cy="1690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74"/>
              </a:spcBef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C3531-EA89-4B49-90D7-B939A10144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4730760" cy="16905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94DA9-A9B8-4217-99C8-859EB97FE5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2308320" cy="16905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687400" y="596880"/>
            <a:ext cx="2308320" cy="16905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C6B68-80C2-49A9-8EA1-7065660E42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58420-E4DA-47C1-B551-BFE1FE2D5E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63160" y="101520"/>
            <a:ext cx="4730760" cy="198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74"/>
              </a:spcBef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8616C-74EA-47F9-BEF8-594BEE0A77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687400" y="596880"/>
            <a:ext cx="2308320" cy="16905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63160" y="147996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69835-2C77-4014-8856-940F8687EA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2308320" cy="16905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687400" y="59688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687400" y="147996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CC15F-04F5-483C-AF8D-1A3B66792C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63160" y="59688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687400" y="596880"/>
            <a:ext cx="230832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63160" y="1479960"/>
            <a:ext cx="4730760" cy="8060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1C60E-6776-4585-BEFB-6591B425F7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63160" y="101520"/>
            <a:ext cx="4730760" cy="4269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63160" y="596880"/>
            <a:ext cx="4730760" cy="169056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rmAutofit fontScale="87000"/>
          </a:bodyPr>
          <a:p>
            <a:pPr marL="144720" indent="-14472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1" marL="316080" indent="-12132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2" marL="486000" indent="-9792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3" marL="679320" indent="-9648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4" marL="874080" indent="-9792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5" marL="874080" indent="-9792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6" marL="874080" indent="-9792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63520" y="2332080"/>
            <a:ext cx="1225440" cy="1778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Autofit/>
          </a:bodyPr>
          <a:lstStyle>
            <a:lvl1pPr indent="0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96760" y="2332080"/>
            <a:ext cx="1663560" cy="1778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Autofit/>
          </a:bodyPr>
          <a:lstStyle>
            <a:lvl1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768840" y="2332080"/>
            <a:ext cx="1225440" cy="177840"/>
          </a:xfrm>
          <a:prstGeom prst="rect">
            <a:avLst/>
          </a:prstGeom>
          <a:noFill/>
          <a:ln w="0">
            <a:noFill/>
          </a:ln>
        </p:spPr>
        <p:txBody>
          <a:bodyPr lIns="44640" rIns="44640" tIns="22320" bIns="22320" anchor="t">
            <a:noAutofit/>
          </a:bodyPr>
          <a:lstStyle>
            <a:lvl1pPr indent="0" algn="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46040"/>
                <a:tab algn="l" pos="892080"/>
                <a:tab algn="l" pos="1338120"/>
                <a:tab algn="l" pos="1784520"/>
                <a:tab algn="l" pos="2230560"/>
                <a:tab algn="l" pos="2676600"/>
                <a:tab algn="l" pos="3122640"/>
                <a:tab algn="l" pos="3568680"/>
                <a:tab algn="l" pos="4014720"/>
                <a:tab algn="l" pos="4460760"/>
                <a:tab algn="l" pos="4906800"/>
                <a:tab algn="l" pos="5353200"/>
                <a:tab algn="l" pos="5799240"/>
                <a:tab algn="l" pos="6245280"/>
                <a:tab algn="l" pos="6691320"/>
                <a:tab algn="l" pos="7137360"/>
                <a:tab algn="l" pos="7583400"/>
                <a:tab algn="l" pos="8029440"/>
                <a:tab algn="l" pos="8475840"/>
                <a:tab algn="l" pos="8921880"/>
              </a:tabLst>
            </a:pPr>
            <a:fld id="{2F7B4CCF-774B-4206-967B-F00B7B40F595}" type="slidenum">
              <a:rPr b="0" lang="en-US" sz="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760" y="87480"/>
            <a:ext cx="5191200" cy="2365200"/>
            <a:chOff x="23760" y="87480"/>
            <a:chExt cx="5191200" cy="236520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0" t="0" r="65817" b="11527"/>
            <a:stretch/>
          </p:blipFill>
          <p:spPr>
            <a:xfrm>
              <a:off x="2632320" y="1405080"/>
              <a:ext cx="633240" cy="390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rcRect l="63518" t="11137" r="18245" b="13042"/>
            <a:stretch/>
          </p:blipFill>
          <p:spPr>
            <a:xfrm>
              <a:off x="1217880" y="2073240"/>
              <a:ext cx="342720" cy="37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rcRect l="31535" t="0" r="36338" b="11527"/>
            <a:stretch/>
          </p:blipFill>
          <p:spPr>
            <a:xfrm>
              <a:off x="1603440" y="1405080"/>
              <a:ext cx="595440" cy="390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rcRect l="62557" t="2872" r="18515" b="5745"/>
            <a:stretch/>
          </p:blipFill>
          <p:spPr>
            <a:xfrm>
              <a:off x="1212840" y="1405080"/>
              <a:ext cx="351000" cy="390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5"/>
            <a:srcRect l="79528" t="-11489" r="1374" b="5745"/>
            <a:stretch/>
          </p:blipFill>
          <p:spPr>
            <a:xfrm>
              <a:off x="2212920" y="1354320"/>
              <a:ext cx="354240" cy="441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6"/>
            <a:srcRect l="33788" t="8792" r="34462" b="17732"/>
            <a:stretch/>
          </p:blipFill>
          <p:spPr>
            <a:xfrm>
              <a:off x="1598760" y="2065320"/>
              <a:ext cx="596880" cy="381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7"/>
            <a:srcRect l="2029" t="6448" r="64191" b="20047"/>
            <a:stretch/>
          </p:blipFill>
          <p:spPr>
            <a:xfrm>
              <a:off x="2621160" y="2065320"/>
              <a:ext cx="635040" cy="381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8"/>
            <a:srcRect l="79528" t="-11489" r="1374" b="5745"/>
            <a:stretch/>
          </p:blipFill>
          <p:spPr>
            <a:xfrm>
              <a:off x="3279960" y="1354320"/>
              <a:ext cx="353880" cy="441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"/>
            <p:cNvSpPr/>
            <p:nvPr/>
          </p:nvSpPr>
          <p:spPr>
            <a:xfrm rot="16200000">
              <a:off x="837720" y="657360"/>
              <a:ext cx="1054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g D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1336320" y="809640"/>
              <a:ext cx="82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1590120" y="771840"/>
              <a:ext cx="825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:1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2377800" y="841680"/>
              <a:ext cx="82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2669760" y="841680"/>
              <a:ext cx="82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:1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6200000">
              <a:off x="1945800" y="841680"/>
              <a:ext cx="82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R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3012840" y="841680"/>
              <a:ext cx="82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R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7" name=""/>
            <p:cNvGrpSpPr/>
            <p:nvPr/>
          </p:nvGrpSpPr>
          <p:grpSpPr>
            <a:xfrm>
              <a:off x="1592280" y="644760"/>
              <a:ext cx="965160" cy="263520"/>
              <a:chOff x="1592280" y="644760"/>
              <a:chExt cx="965160" cy="263520"/>
            </a:xfrm>
          </p:grpSpPr>
          <p:sp>
            <p:nvSpPr>
              <p:cNvPr id="58" name=""/>
              <p:cNvSpPr/>
              <p:nvPr/>
            </p:nvSpPr>
            <p:spPr>
              <a:xfrm>
                <a:off x="1592280" y="654480"/>
                <a:ext cx="9651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595520" y="644760"/>
                <a:ext cx="0" cy="2541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2543400" y="654480"/>
                <a:ext cx="0" cy="2538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1" name=""/>
            <p:cNvGrpSpPr/>
            <p:nvPr/>
          </p:nvGrpSpPr>
          <p:grpSpPr>
            <a:xfrm>
              <a:off x="2646360" y="644760"/>
              <a:ext cx="965160" cy="263520"/>
              <a:chOff x="2646360" y="644760"/>
              <a:chExt cx="965160" cy="263520"/>
            </a:xfrm>
          </p:grpSpPr>
          <p:sp>
            <p:nvSpPr>
              <p:cNvPr id="62" name=""/>
              <p:cNvSpPr/>
              <p:nvPr/>
            </p:nvSpPr>
            <p:spPr>
              <a:xfrm>
                <a:off x="2646360" y="654480"/>
                <a:ext cx="9651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649600" y="644760"/>
                <a:ext cx="0" cy="2541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597480" y="654480"/>
                <a:ext cx="0" cy="2538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5" name=""/>
            <p:cNvSpPr/>
            <p:nvPr/>
          </p:nvSpPr>
          <p:spPr>
            <a:xfrm>
              <a:off x="1690920" y="351000"/>
              <a:ext cx="87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656080" y="351000"/>
              <a:ext cx="120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-AzaC 7-da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7" name="" descr=""/>
            <p:cNvPicPr/>
            <p:nvPr/>
          </p:nvPicPr>
          <p:blipFill>
            <a:blip r:embed="rId9"/>
            <a:srcRect l="79528" t="-11489" r="1374" b="5745"/>
            <a:stretch/>
          </p:blipFill>
          <p:spPr>
            <a:xfrm>
              <a:off x="2212920" y="2021040"/>
              <a:ext cx="354240" cy="43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" descr=""/>
            <p:cNvPicPr/>
            <p:nvPr/>
          </p:nvPicPr>
          <p:blipFill>
            <a:blip r:embed="rId10"/>
            <a:srcRect l="79528" t="-11489" r="1374" b="5745"/>
            <a:stretch/>
          </p:blipFill>
          <p:spPr>
            <a:xfrm>
              <a:off x="3279960" y="2021040"/>
              <a:ext cx="353880" cy="431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3691080" y="1449360"/>
              <a:ext cx="1027080" cy="32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92.m0008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(Ehsp10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417680" y="87480"/>
              <a:ext cx="2530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E. histolytic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HM-1:IMSS c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681360" y="2106720"/>
              <a:ext cx="1533600" cy="32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47.m000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(RNA polymerase II L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3760" y="163440"/>
              <a:ext cx="115272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icroarray expression fold-chan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62080" y="2106720"/>
              <a:ext cx="55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.2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71440" y="1459080"/>
              <a:ext cx="552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.1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30T17:09:45Z</dcterms:created>
  <dc:creator>Bioinformatics Resource</dc:creator>
  <dc:description/>
  <dc:language>en-US</dc:language>
  <cp:lastModifiedBy>Upinder Singh</cp:lastModifiedBy>
  <dcterms:modified xsi:type="dcterms:W3CDTF">2007-01-04T17:08:21Z</dcterms:modified>
  <cp:revision>10</cp:revision>
  <dc:subject/>
  <dc:title>Slide 1</dc:title>
</cp:coreProperties>
</file>